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298B4F-497D-D3B1-FDC7-1DCFEBD7ED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9F61D4-6C44-88F3-4CC4-FCD3E6E7D9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234516-FEBA-5022-FAE3-BD121C53F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6A92E0-24F2-6BF6-B15F-1C3C813F5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E53323-9749-11AA-9DFF-0855DF512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109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758EC6-28AC-D0DE-553A-30B03733A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ADB959-7D3D-4244-23AB-FAEAF1E2E1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FCB1E9-06B1-4B29-5297-1B64816FB9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F97D0A-DDD5-B9DA-D8A9-A397DAAC13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BC1F92-EA98-3188-ED2E-4376BAC7C6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6094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19BDD11-B498-F687-6561-59CE691339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2A1C18-1BBD-B5CC-2A5A-4C055F4C5D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9CE5AD-26AC-74A7-FB14-7B3A07F7A2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1BA6C-B000-A015-2C34-069585DEC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4441F6-A6ED-3B5C-9679-A05DBF3196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1920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BE83C2-498B-B62F-777F-0BA4269520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3A0B99-202C-7930-DA63-9F105F4FA0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5C6454-6EB8-114B-376D-8CB4C1DEB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FACCC7-CD3B-AE5D-3F5A-30E5D66855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1405C3-5F50-1575-9D88-68629F505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3472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B77B25-D767-4A0B-029C-C7B6EBA5CC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246415-61F4-E661-0923-1864428892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2E2E80-E67D-2624-8AAC-33B023752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682861-ED42-5C57-C21D-BAFF1CB3E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0726B4-123E-311A-715B-8FF9111B1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024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225614-3B35-EC1E-3328-A7077D5CF2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AE88A9-2D89-AC37-0CE5-849ED5FB9C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CBA0E4-CED1-258C-739C-AC543F72B0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9D9AA4-E237-6927-AA08-6B2DD9AFB2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A0DF3C-BF17-EAB6-D7AA-683DB98464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4CE807-5049-06D3-4CA9-41E08ABB0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332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606C62-0726-8E0F-81A5-1492BF9608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A03565-6A67-88CD-1558-34B893A50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BC2493-463F-FEBB-3E14-1E33411544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9C25BE4-DAA3-D662-D330-0808524C569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4395FA4-2655-A2F4-B7CD-CEE0607E8C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D52E62-7EBB-02D0-7F3E-C358D17FD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48880EC-32E2-C862-DF8F-6E875249E7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911D1F-EEF1-5336-949A-35B229875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726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96962D-72BB-8B68-EFEF-FA9009415E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936069C-CFCC-34CE-2CD1-92C5BEA45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4F6923-07FF-5A32-16CB-47297EF71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0E2FB84-80C2-F33C-9443-0DFF092AF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866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677900-1366-CDBB-1645-EE83C94497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D8F0F3-0421-FF93-5010-6BF16B7BB5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B667204-3987-BD1F-E291-F06929A4F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833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141F40-F482-5554-3DE4-80FE3E68CA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333B11-A359-3474-D4FF-A02E501F76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18C943-04A3-578B-9D39-805F162DD9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FE0925-B81A-AFD4-3D9D-66C372A00E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E8CBA1-C000-63A1-8617-2CE70D527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B42AB6-141F-EA9C-EF41-A798B93038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7073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5A3C88-7DD1-5C20-20E3-2E095CB3A8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502417-D64D-D8ED-DB51-9FDFD0FA24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845367-A99C-5A44-81E6-5C54AF336D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AA72D1-4CAF-A045-4307-0771A273C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BC8D8D-8429-DB9D-27C8-851C8E143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DF0D97-89BB-ADFE-75C8-24834A872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4028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2BA7F8-C412-B14C-A8E0-2193EFEE89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4D4C6D-9D92-5279-811A-FC97A4EE47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678571-1F9E-5ABD-83E3-827F9326E7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31C87D6-DBAE-5B43-A773-B7D378F03F5D}" type="datetimeFigureOut">
              <a:rPr lang="en-US" smtClean="0"/>
              <a:t>7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241C20-236D-D30C-7610-B23EEA0DA7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D6EE7F-685B-B7F4-46A0-C78031C1AA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5BE42D-F8AF-084D-AA61-243F018B2A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2409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7" Type="http://schemas.openxmlformats.org/officeDocument/2006/relationships/image" Target="../media/image18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tiff"/><Relationship Id="rId5" Type="http://schemas.openxmlformats.org/officeDocument/2006/relationships/image" Target="../media/image16.tiff"/><Relationship Id="rId4" Type="http://schemas.openxmlformats.org/officeDocument/2006/relationships/image" Target="../media/image15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42A4FC2C-047E-45A5-965D-8E1E3BF09BC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white">
          <a:xfrm>
            <a:off x="1524" y="0"/>
            <a:ext cx="12188952" cy="6858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4BDD1C8-91E1-C282-0ADB-06ECC3FC035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2092" y="2747576"/>
            <a:ext cx="3911600" cy="19177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9470B8D-1EC2-758E-694B-59F06FA658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2092" y="554853"/>
            <a:ext cx="3911600" cy="19177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A0B524D0-2F55-D3BE-122F-4F408EB2697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2092" y="4921764"/>
            <a:ext cx="3911600" cy="19177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10D9AC5-403C-CE7F-EDCC-44D63288A5D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77919" y="554853"/>
            <a:ext cx="3911600" cy="19177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86A1377-0CAE-DA5A-008C-C96EB24C94E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43822" y="2877923"/>
            <a:ext cx="3911600" cy="19177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CA4E92F-3ED0-3B33-4F2D-6863AF0CDF5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66284" y="4940300"/>
            <a:ext cx="3911600" cy="19177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48D5FCC1-FAB8-31D4-2A51-623041525F1E}"/>
              </a:ext>
            </a:extLst>
          </p:cNvPr>
          <p:cNvSpPr txBox="1"/>
          <p:nvPr/>
        </p:nvSpPr>
        <p:spPr>
          <a:xfrm>
            <a:off x="4653692" y="113183"/>
            <a:ext cx="28929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JAB; left CD47, right CD69</a:t>
            </a:r>
          </a:p>
        </p:txBody>
      </p:sp>
    </p:spTree>
    <p:extLst>
      <p:ext uri="{BB962C8B-B14F-4D97-AF65-F5344CB8AC3E}">
        <p14:creationId xmlns:p14="http://schemas.microsoft.com/office/powerpoint/2010/main" val="1850287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716561A-6461-B405-A5A0-23C0CA87F5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264" y="542496"/>
            <a:ext cx="3949700" cy="19177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C747193-0E64-ED36-D054-FBB1E012BC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8264" y="2914993"/>
            <a:ext cx="3949700" cy="19177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FB8019C1-13AF-61D5-09FD-92FEF72076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8264" y="4940300"/>
            <a:ext cx="3949700" cy="19177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E6BAAA5-0749-C48D-F68A-C68ADC1497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43075" y="678420"/>
            <a:ext cx="3949700" cy="19177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9204946-467C-798F-AE61-A0148943125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49426" y="2741999"/>
            <a:ext cx="3949700" cy="19177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1E733D6-939F-3D08-9E3D-CC0F3A12E4D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40783" y="4858608"/>
            <a:ext cx="3949700" cy="19177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5A1C822-43A4-A649-1A8E-38BA73F4C0BF}"/>
              </a:ext>
            </a:extLst>
          </p:cNvPr>
          <p:cNvSpPr txBox="1"/>
          <p:nvPr/>
        </p:nvSpPr>
        <p:spPr>
          <a:xfrm>
            <a:off x="4653692" y="113183"/>
            <a:ext cx="2821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JI; left CD47, right CD69</a:t>
            </a:r>
          </a:p>
        </p:txBody>
      </p:sp>
    </p:spTree>
    <p:extLst>
      <p:ext uri="{BB962C8B-B14F-4D97-AF65-F5344CB8AC3E}">
        <p14:creationId xmlns:p14="http://schemas.microsoft.com/office/powerpoint/2010/main" val="1340108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086BE19-FBB9-9D35-B5EE-9F0308020F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410" y="357145"/>
            <a:ext cx="3949700" cy="19177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8208F2C-2178-0530-1DA0-41F58F878F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9410" y="2470150"/>
            <a:ext cx="3949700" cy="19177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06C5D1D-20F3-A271-B7BB-C86C7FC686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9410" y="4731437"/>
            <a:ext cx="3949700" cy="19177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3CA6AB6-94D3-64B7-898C-83C56097A14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20653" y="400394"/>
            <a:ext cx="3949700" cy="19177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CD7ED41-F793-8A79-D573-463643055D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19507" y="2470150"/>
            <a:ext cx="3949700" cy="19177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B985CE8-EF13-5AB4-FDEF-9910742B906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29572" y="4663475"/>
            <a:ext cx="3949700" cy="19177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C6E83412-150D-1960-6CA2-B3B6E82204E5}"/>
              </a:ext>
            </a:extLst>
          </p:cNvPr>
          <p:cNvSpPr txBox="1"/>
          <p:nvPr/>
        </p:nvSpPr>
        <p:spPr>
          <a:xfrm>
            <a:off x="4653692" y="113183"/>
            <a:ext cx="30842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CBL1; </a:t>
            </a:r>
            <a:r>
              <a:rPr lang="en-US" dirty="0"/>
              <a:t>left CD47, right CD69</a:t>
            </a:r>
          </a:p>
        </p:txBody>
      </p:sp>
    </p:spTree>
    <p:extLst>
      <p:ext uri="{BB962C8B-B14F-4D97-AF65-F5344CB8AC3E}">
        <p14:creationId xmlns:p14="http://schemas.microsoft.com/office/powerpoint/2010/main" val="37479994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72DC340-F2A3-8C39-3B1E-CAF71D9B00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8930" y="716692"/>
            <a:ext cx="6835174" cy="368351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131A5AE-34A4-2BF4-DC2A-09DF10AF8623}"/>
              </a:ext>
            </a:extLst>
          </p:cNvPr>
          <p:cNvSpPr txBox="1"/>
          <p:nvPr/>
        </p:nvSpPr>
        <p:spPr>
          <a:xfrm>
            <a:off x="4917989" y="185351"/>
            <a:ext cx="49482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D47 overlay from three cell lines -nonactivated</a:t>
            </a:r>
          </a:p>
        </p:txBody>
      </p:sp>
    </p:spTree>
    <p:extLst>
      <p:ext uri="{BB962C8B-B14F-4D97-AF65-F5344CB8AC3E}">
        <p14:creationId xmlns:p14="http://schemas.microsoft.com/office/powerpoint/2010/main" val="1968379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29</Words>
  <Application>Microsoft Macintosh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ngh, Satya (NIH/NIAID) [E]</dc:creator>
  <cp:lastModifiedBy>Singh, Satya (NIH/NIAID) [E]</cp:lastModifiedBy>
  <cp:revision>3</cp:revision>
  <dcterms:created xsi:type="dcterms:W3CDTF">2025-07-10T20:20:16Z</dcterms:created>
  <dcterms:modified xsi:type="dcterms:W3CDTF">2025-07-10T20:37:40Z</dcterms:modified>
</cp:coreProperties>
</file>